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7772400" cy="10058400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-2016" y="-128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045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210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110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472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495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57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07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576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484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946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118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498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668161" y="1742775"/>
            <a:ext cx="4980877" cy="387705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668161" y="5733534"/>
            <a:ext cx="53751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curves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omparing PFS in patients with high (&gt; 500) and low (&lt; 500) serum AFP.  Log-rank test demonstrated no significant association between PFS and serum AFP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07447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47</TotalTime>
  <Words>41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tg55</dc:creator>
  <cp:lastModifiedBy>Ryan T</cp:lastModifiedBy>
  <cp:revision>23</cp:revision>
  <cp:lastPrinted>2015-04-23T21:25:43Z</cp:lastPrinted>
  <dcterms:created xsi:type="dcterms:W3CDTF">2015-04-23T20:59:46Z</dcterms:created>
  <dcterms:modified xsi:type="dcterms:W3CDTF">2015-05-29T02:10:22Z</dcterms:modified>
</cp:coreProperties>
</file>